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93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791C2-FB86-4A6F-A337-722C50476402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3B424-9420-4A0E-8641-5FA4594D0DD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4387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791C2-FB86-4A6F-A337-722C50476402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3B424-9420-4A0E-8641-5FA4594D0DD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027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791C2-FB86-4A6F-A337-722C50476402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3B424-9420-4A0E-8641-5FA4594D0DD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4795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791C2-FB86-4A6F-A337-722C50476402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3B424-9420-4A0E-8641-5FA4594D0DD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28052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791C2-FB86-4A6F-A337-722C50476402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3B424-9420-4A0E-8641-5FA4594D0DD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4502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791C2-FB86-4A6F-A337-722C50476402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3B424-9420-4A0E-8641-5FA4594D0DD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5773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791C2-FB86-4A6F-A337-722C50476402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3B424-9420-4A0E-8641-5FA4594D0DD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4711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791C2-FB86-4A6F-A337-722C50476402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3B424-9420-4A0E-8641-5FA4594D0DD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6247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791C2-FB86-4A6F-A337-722C50476402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3B424-9420-4A0E-8641-5FA4594D0DD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261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791C2-FB86-4A6F-A337-722C50476402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3B424-9420-4A0E-8641-5FA4594D0DD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03394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791C2-FB86-4A6F-A337-722C50476402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3B424-9420-4A0E-8641-5FA4594D0DD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27926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5791C2-FB86-4A6F-A337-722C50476402}" type="datetimeFigureOut">
              <a:rPr lang="en-GB" smtClean="0"/>
              <a:t>28/01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F3B424-9420-4A0E-8641-5FA4594D0DD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96452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01686370"/>
              </p:ext>
            </p:extLst>
          </p:nvPr>
        </p:nvGraphicFramePr>
        <p:xfrm>
          <a:off x="302391" y="949663"/>
          <a:ext cx="5486400" cy="1650873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371600">
                  <a:extLst>
                    <a:ext uri="{9D8B030D-6E8A-4147-A177-3AD203B41FA5}">
                      <a16:colId xmlns:a16="http://schemas.microsoft.com/office/drawing/2014/main" val="732955435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1307927923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1717736251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4293661698"/>
                    </a:ext>
                  </a:extLst>
                </a:gridCol>
              </a:tblGrid>
              <a:tr h="15131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Variable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β coefficient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95% CI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p-value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494927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ETs quartile 2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.348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8.681 to 11.377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792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733557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ETs quartile 3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1.026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11.232 to 9.179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843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226832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ETs quartile 4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6.997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17.418 to 3.424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88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2429675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ge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66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0.202 to 0.334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63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136355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Sex (male)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6.01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1.294 to 13.314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07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062632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Diabetes duration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184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[-0.462 to 0.094]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94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239452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Lipid-lowering therapy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11.338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19.801 to -2.876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9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03220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nnual income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00118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[-0.000722 to 0.000485]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7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71904810"/>
                  </a:ext>
                </a:extLst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245155" y="233725"/>
            <a:ext cx="3539239" cy="8001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304704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  <a:ea typeface="MS Gothic" panose="020B0609070205080204" pitchFamily="49" charset="-128"/>
                <a:cs typeface="Times New Roman" panose="02020603050405020304" pitchFamily="18" charset="0"/>
              </a:rPr>
              <a:t>Linear regression of total cholesterol (mg/</a:t>
            </a:r>
            <a:r>
              <a:rPr kumimoji="0" lang="en-US" altLang="en-US" sz="1400" b="1" i="0" u="none" strike="noStrike" cap="none" normalizeH="0" baseline="0" dirty="0" err="1" smtClean="0">
                <a:ln>
                  <a:noFill/>
                </a:ln>
                <a:effectLst/>
                <a:latin typeface="Calibri" panose="020F0502020204030204" pitchFamily="34" charset="0"/>
                <a:ea typeface="MS Gothic" panose="020B0609070205080204" pitchFamily="49" charset="-128"/>
                <a:cs typeface="Times New Roman" panose="02020603050405020304" pitchFamily="18" charset="0"/>
              </a:rPr>
              <a:t>dL</a:t>
            </a: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  <a:ea typeface="MS Gothic" panose="020B0609070205080204" pitchFamily="49" charset="-128"/>
                <a:cs typeface="Times New Roman" panose="02020603050405020304" pitchFamily="18" charset="0"/>
              </a:rPr>
              <a:t>)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6" name="Tab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6136185"/>
              </p:ext>
            </p:extLst>
          </p:nvPr>
        </p:nvGraphicFramePr>
        <p:xfrm>
          <a:off x="245155" y="3026059"/>
          <a:ext cx="5486400" cy="1658741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371600">
                  <a:extLst>
                    <a:ext uri="{9D8B030D-6E8A-4147-A177-3AD203B41FA5}">
                      <a16:colId xmlns:a16="http://schemas.microsoft.com/office/drawing/2014/main" val="736859462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2728906875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1054981583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361423602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Variable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β coefficient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95% CI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p-value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873101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ETs quartile 2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.396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7.484 to 10.275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757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713936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ETs quartile 3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-3.55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12.543 to 5.444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438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489118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METs quartile 4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7.282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16.449 to 1.885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19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3635738"/>
                  </a:ext>
                </a:extLst>
              </a:tr>
              <a:tr h="17182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ge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59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0.295 to 0.176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62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188171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Sex (male)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1.766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8.257 to 4.724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593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750709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Diabetes duration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162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0.408 to 0.083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95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441835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Lipid-lowering therapy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-9.123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16.554 to -1.693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16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592171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nnual income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000121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0.000408 to 0.000649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653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70946787"/>
                  </a:ext>
                </a:extLst>
              </a:tr>
            </a:tbl>
          </a:graphicData>
        </a:graphic>
      </p:graphicFrame>
      <p:sp>
        <p:nvSpPr>
          <p:cNvPr id="7" name="Rectangle 2"/>
          <p:cNvSpPr>
            <a:spLocks noChangeArrowheads="1"/>
          </p:cNvSpPr>
          <p:nvPr/>
        </p:nvSpPr>
        <p:spPr bwMode="auto">
          <a:xfrm>
            <a:off x="331461" y="2457300"/>
            <a:ext cx="3452933" cy="8001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304704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  <a:ea typeface="MS Gothic" panose="020B0609070205080204" pitchFamily="49" charset="-128"/>
                <a:cs typeface="Times New Roman" panose="02020603050405020304" pitchFamily="18" charset="0"/>
              </a:rPr>
              <a:t>Linear regression of LDL cholesterol (mg/</a:t>
            </a:r>
            <a:r>
              <a:rPr kumimoji="0" lang="en-US" altLang="en-US" sz="1400" b="1" i="0" u="none" strike="noStrike" cap="none" normalizeH="0" baseline="0" dirty="0" err="1" smtClean="0">
                <a:ln>
                  <a:noFill/>
                </a:ln>
                <a:effectLst/>
                <a:latin typeface="Calibri" panose="020F0502020204030204" pitchFamily="34" charset="0"/>
                <a:ea typeface="MS Gothic" panose="020B0609070205080204" pitchFamily="49" charset="-128"/>
                <a:cs typeface="Times New Roman" panose="02020603050405020304" pitchFamily="18" charset="0"/>
              </a:rPr>
              <a:t>dL</a:t>
            </a: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  <a:ea typeface="MS Gothic" panose="020B0609070205080204" pitchFamily="49" charset="-128"/>
                <a:cs typeface="Times New Roman" panose="02020603050405020304" pitchFamily="18" charset="0"/>
              </a:rPr>
              <a:t>)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8" name="Tabla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2872894"/>
              </p:ext>
            </p:extLst>
          </p:nvPr>
        </p:nvGraphicFramePr>
        <p:xfrm>
          <a:off x="6333943" y="949663"/>
          <a:ext cx="5486400" cy="1664315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371600">
                  <a:extLst>
                    <a:ext uri="{9D8B030D-6E8A-4147-A177-3AD203B41FA5}">
                      <a16:colId xmlns:a16="http://schemas.microsoft.com/office/drawing/2014/main" val="3356846645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2546040995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3477613743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1346734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Variable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β coefficient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95% CI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p-value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267343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ETs quartile 2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.5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1.860 to 6.860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26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398718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ETs quartile 3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7.333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2.917 to 11.749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1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5346257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ETs quartile 4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.616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1.102 to 10.130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15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83244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ge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08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0.007 to 0.224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66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53336089"/>
                  </a:ext>
                </a:extLst>
              </a:tr>
              <a:tr h="17739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Sex (male)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8.069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4.880 to 11.258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648977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Diabetes duration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13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0.133 to 0.108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837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61475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Lipid-lowering therapy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4.419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8.068 to -0.771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18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560395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nnual income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-7.3e-05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0.000333 to 0.000186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579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93631801"/>
                  </a:ext>
                </a:extLst>
              </a:tr>
            </a:tbl>
          </a:graphicData>
        </a:graphic>
      </p:graphicFrame>
      <p:sp>
        <p:nvSpPr>
          <p:cNvPr id="9" name="Rectangle 3"/>
          <p:cNvSpPr>
            <a:spLocks noChangeArrowheads="1"/>
          </p:cNvSpPr>
          <p:nvPr/>
        </p:nvSpPr>
        <p:spPr bwMode="auto">
          <a:xfrm>
            <a:off x="6204178" y="56482"/>
            <a:ext cx="3491405" cy="8001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304704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  <a:ea typeface="MS Gothic" panose="020B0609070205080204" pitchFamily="49" charset="-128"/>
                <a:cs typeface="Times New Roman" panose="02020603050405020304" pitchFamily="18" charset="0"/>
              </a:rPr>
              <a:t>Linear regression of HDL cholesterol (mg/</a:t>
            </a:r>
            <a:r>
              <a:rPr kumimoji="0" lang="en-US" altLang="en-US" sz="1400" b="1" i="0" u="none" strike="noStrike" cap="none" normalizeH="0" baseline="0" dirty="0" err="1" smtClean="0">
                <a:ln>
                  <a:noFill/>
                </a:ln>
                <a:effectLst/>
                <a:latin typeface="Calibri" panose="020F0502020204030204" pitchFamily="34" charset="0"/>
                <a:ea typeface="MS Gothic" panose="020B0609070205080204" pitchFamily="49" charset="-128"/>
                <a:cs typeface="Times New Roman" panose="02020603050405020304" pitchFamily="18" charset="0"/>
              </a:rPr>
              <a:t>dL</a:t>
            </a: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  <a:ea typeface="MS Gothic" panose="020B0609070205080204" pitchFamily="49" charset="-128"/>
                <a:cs typeface="Times New Roman" panose="02020603050405020304" pitchFamily="18" charset="0"/>
              </a:rPr>
              <a:t>)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10" name="Tabla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8691962"/>
              </p:ext>
            </p:extLst>
          </p:nvPr>
        </p:nvGraphicFramePr>
        <p:xfrm>
          <a:off x="6333943" y="3017006"/>
          <a:ext cx="5486400" cy="1650873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371600">
                  <a:extLst>
                    <a:ext uri="{9D8B030D-6E8A-4147-A177-3AD203B41FA5}">
                      <a16:colId xmlns:a16="http://schemas.microsoft.com/office/drawing/2014/main" val="3753247742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2667032885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1559391024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290685774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Variable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β coefficient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95% CI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p-value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056474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ETs quartile 2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12.992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25.213 to -0.770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037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441282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ETs quartile 3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18.579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31.117 to -6.041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4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9307247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ETs quartile 4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19.344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32.165 to -6.524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3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247722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ge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48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0.181 to 0.476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377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000432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Sex (male)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9.56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18.554 to -0.566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37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760420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Diabetes duration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132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0.473 to 0.210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449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122205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Lipid-lowering therapy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7.006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3.406 to 17.419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87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333083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nnual income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00664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0.001401 to 0.000073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077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97798393"/>
                  </a:ext>
                </a:extLst>
              </a:tr>
            </a:tbl>
          </a:graphicData>
        </a:graphic>
      </p:graphicFrame>
      <p:sp>
        <p:nvSpPr>
          <p:cNvPr id="11" name="Rectangle 4"/>
          <p:cNvSpPr>
            <a:spLocks noChangeArrowheads="1"/>
          </p:cNvSpPr>
          <p:nvPr/>
        </p:nvSpPr>
        <p:spPr bwMode="auto">
          <a:xfrm>
            <a:off x="6204178" y="2415597"/>
            <a:ext cx="3328732" cy="8001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304704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  <a:ea typeface="MS Gothic" panose="020B0609070205080204" pitchFamily="49" charset="-128"/>
                <a:cs typeface="Times New Roman" panose="02020603050405020304" pitchFamily="18" charset="0"/>
              </a:rPr>
              <a:t> Linear regression of triglycerides (mg/</a:t>
            </a:r>
            <a:r>
              <a:rPr kumimoji="0" lang="en-US" altLang="en-US" sz="1400" b="1" i="0" u="none" strike="noStrike" cap="none" normalizeH="0" baseline="0" dirty="0" err="1" smtClean="0">
                <a:ln>
                  <a:noFill/>
                </a:ln>
                <a:effectLst/>
                <a:latin typeface="Calibri" panose="020F0502020204030204" pitchFamily="34" charset="0"/>
                <a:ea typeface="MS Gothic" panose="020B0609070205080204" pitchFamily="49" charset="-128"/>
                <a:cs typeface="Times New Roman" panose="02020603050405020304" pitchFamily="18" charset="0"/>
              </a:rPr>
              <a:t>dL</a:t>
            </a: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  <a:ea typeface="MS Gothic" panose="020B0609070205080204" pitchFamily="49" charset="-128"/>
                <a:cs typeface="Times New Roman" panose="02020603050405020304" pitchFamily="18" charset="0"/>
              </a:rPr>
              <a:t>)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12" name="Tabla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0523894"/>
              </p:ext>
            </p:extLst>
          </p:nvPr>
        </p:nvGraphicFramePr>
        <p:xfrm>
          <a:off x="344432" y="5079082"/>
          <a:ext cx="5486400" cy="1730317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371600">
                  <a:extLst>
                    <a:ext uri="{9D8B030D-6E8A-4147-A177-3AD203B41FA5}">
                      <a16:colId xmlns:a16="http://schemas.microsoft.com/office/drawing/2014/main" val="3870355235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3011905429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3413173657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51894058"/>
                    </a:ext>
                  </a:extLst>
                </a:gridCol>
              </a:tblGrid>
              <a:tr h="1460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Variable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β coefficient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95% CI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p-value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41762793"/>
                  </a:ext>
                </a:extLst>
              </a:tr>
              <a:tr h="1460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ETs quartile 2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3.459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6.248 to -0.670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15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53298752"/>
                  </a:ext>
                </a:extLst>
              </a:tr>
              <a:tr h="1460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ETs quartile 3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4.484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7.309 to -1.659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2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46433491"/>
                  </a:ext>
                </a:extLst>
              </a:tr>
              <a:tr h="1460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ETs quartile 4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4.599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7.487 to -1.711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2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2417363"/>
                  </a:ext>
                </a:extLst>
              </a:tr>
              <a:tr h="1460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ge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2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0.054 to 0.094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594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87293013"/>
                  </a:ext>
                </a:extLst>
              </a:tr>
              <a:tr h="1460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Sex (male)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1.79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3.830 to 0.250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85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73788642"/>
                  </a:ext>
                </a:extLst>
              </a:tr>
              <a:tr h="24340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Diabetes duration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33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0.111 to 0.044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395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88037654"/>
                  </a:ext>
                </a:extLst>
              </a:tr>
              <a:tr h="1460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Lipid-lowering therapy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.248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[-1.086 to 3.582]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294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12742441"/>
                  </a:ext>
                </a:extLst>
              </a:tr>
              <a:tr h="29218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nnual income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00145</a:t>
                      </a:r>
                      <a:endParaRPr lang="en-GB" sz="10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[-0.000311 to 0.000022]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088</a:t>
                      </a:r>
                      <a:endParaRPr lang="en-GB" sz="10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33988800"/>
                  </a:ext>
                </a:extLst>
              </a:tr>
            </a:tbl>
          </a:graphicData>
        </a:graphic>
      </p:graphicFrame>
      <p:sp>
        <p:nvSpPr>
          <p:cNvPr id="13" name="Rectangle 5"/>
          <p:cNvSpPr>
            <a:spLocks noChangeArrowheads="1"/>
          </p:cNvSpPr>
          <p:nvPr/>
        </p:nvSpPr>
        <p:spPr bwMode="auto">
          <a:xfrm>
            <a:off x="331461" y="4547296"/>
            <a:ext cx="3827586" cy="8001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304704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  <a:ea typeface="MS Gothic" panose="020B0609070205080204" pitchFamily="49" charset="-128"/>
                <a:cs typeface="Times New Roman" panose="02020603050405020304" pitchFamily="18" charset="0"/>
              </a:rPr>
              <a:t>Linear regression of remnant cholesterol (mg/</a:t>
            </a:r>
            <a:r>
              <a:rPr kumimoji="0" lang="en-US" altLang="en-US" sz="1400" b="1" i="0" u="none" strike="noStrike" cap="none" normalizeH="0" baseline="0" dirty="0" err="1" smtClean="0">
                <a:ln>
                  <a:noFill/>
                </a:ln>
                <a:effectLst/>
                <a:latin typeface="Calibri" panose="020F0502020204030204" pitchFamily="34" charset="0"/>
                <a:ea typeface="MS Gothic" panose="020B0609070205080204" pitchFamily="49" charset="-128"/>
                <a:cs typeface="Times New Roman" panose="02020603050405020304" pitchFamily="18" charset="0"/>
              </a:rPr>
              <a:t>dL</a:t>
            </a: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  <a:ea typeface="MS Gothic" panose="020B0609070205080204" pitchFamily="49" charset="-128"/>
                <a:cs typeface="Times New Roman" panose="02020603050405020304" pitchFamily="18" charset="0"/>
              </a:rPr>
              <a:t>)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4" name="CuadroTexto 13"/>
          <p:cNvSpPr txBox="1"/>
          <p:nvPr/>
        </p:nvSpPr>
        <p:spPr>
          <a:xfrm>
            <a:off x="344431" y="56482"/>
            <a:ext cx="43522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 smtClean="0"/>
              <a:t>Supplementary</a:t>
            </a:r>
            <a:r>
              <a:rPr lang="es-ES" b="1" smtClean="0"/>
              <a:t> </a:t>
            </a:r>
            <a:r>
              <a:rPr lang="es-ES" b="1" smtClean="0"/>
              <a:t>Material S6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673463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494</Words>
  <Application>Microsoft Office PowerPoint</Application>
  <PresentationFormat>Panorámica</PresentationFormat>
  <Paragraphs>18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7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9" baseType="lpstr">
      <vt:lpstr>MS Gothic</vt:lpstr>
      <vt:lpstr>Arial</vt:lpstr>
      <vt:lpstr>Calibri</vt:lpstr>
      <vt:lpstr>Calibri Light</vt:lpstr>
      <vt:lpstr>Cambria</vt:lpstr>
      <vt:lpstr>MS Mincho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o</dc:creator>
  <cp:lastModifiedBy>Fernando</cp:lastModifiedBy>
  <cp:revision>5</cp:revision>
  <dcterms:created xsi:type="dcterms:W3CDTF">2025-07-22T12:44:04Z</dcterms:created>
  <dcterms:modified xsi:type="dcterms:W3CDTF">2026-01-28T11:25:48Z</dcterms:modified>
</cp:coreProperties>
</file>